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8" autoAdjust="0"/>
    <p:restoredTop sz="94660"/>
  </p:normalViewPr>
  <p:slideViewPr>
    <p:cSldViewPr snapToGrid="0">
      <p:cViewPr varScale="1">
        <p:scale>
          <a:sx n="56" d="100"/>
          <a:sy n="56" d="100"/>
        </p:scale>
        <p:origin x="2259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6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999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504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18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90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262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101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445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103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9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903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B71AEE-4079-436A-93F9-F6A1DE56E1D9}" type="datetimeFigureOut">
              <a:rPr lang="en-US" smtClean="0"/>
              <a:t>10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858B08-3A51-4955-9C78-2A578557AF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329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그룹 52">
            <a:extLst>
              <a:ext uri="{FF2B5EF4-FFF2-40B4-BE49-F238E27FC236}">
                <a16:creationId xmlns:a16="http://schemas.microsoft.com/office/drawing/2014/main" id="{A5977E1B-4C6A-DDB1-EEB8-6021AEF055A2}"/>
              </a:ext>
            </a:extLst>
          </p:cNvPr>
          <p:cNvGrpSpPr/>
          <p:nvPr/>
        </p:nvGrpSpPr>
        <p:grpSpPr>
          <a:xfrm>
            <a:off x="311828" y="1057436"/>
            <a:ext cx="2902740" cy="2902585"/>
            <a:chOff x="311828" y="2075024"/>
            <a:chExt cx="2902740" cy="2902585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D255DF0E-4DAE-83C9-199D-2A004C6BC8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1828" y="2336634"/>
              <a:ext cx="2902740" cy="264097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E6D7CC3-8853-C8B3-2B5F-AE90904C2350}"/>
                </a:ext>
              </a:extLst>
            </p:cNvPr>
            <p:cNvSpPr txBox="1"/>
            <p:nvPr/>
          </p:nvSpPr>
          <p:spPr>
            <a:xfrm>
              <a:off x="311828" y="2075024"/>
              <a:ext cx="2902740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C</a:t>
              </a:r>
            </a:p>
          </p:txBody>
        </p:sp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7799708A-A575-D321-2D48-3A8F35334257}"/>
                </a:ext>
              </a:extLst>
            </p:cNvPr>
            <p:cNvSpPr/>
            <p:nvPr/>
          </p:nvSpPr>
          <p:spPr>
            <a:xfrm>
              <a:off x="2016917" y="3460863"/>
              <a:ext cx="456983" cy="19625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FB347AD-1FAA-D7DF-91C6-3EA27345D654}"/>
                </a:ext>
              </a:extLst>
            </p:cNvPr>
            <p:cNvSpPr txBox="1"/>
            <p:nvPr/>
          </p:nvSpPr>
          <p:spPr>
            <a:xfrm>
              <a:off x="1846303" y="3234533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PINE1</a:t>
              </a:r>
            </a:p>
          </p:txBody>
        </p: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F1D6297A-68C4-FBA5-4726-558988812DEC}"/>
                </a:ext>
              </a:extLst>
            </p:cNvPr>
            <p:cNvSpPr/>
            <p:nvPr/>
          </p:nvSpPr>
          <p:spPr>
            <a:xfrm>
              <a:off x="2039699" y="4371061"/>
              <a:ext cx="456983" cy="19625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7AC3E5-E49C-FD4D-5659-3E93F07638A6}"/>
                </a:ext>
              </a:extLst>
            </p:cNvPr>
            <p:cNvSpPr txBox="1"/>
            <p:nvPr/>
          </p:nvSpPr>
          <p:spPr>
            <a:xfrm>
              <a:off x="1950386" y="4140888"/>
              <a:ext cx="6516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grpSp>
        <p:nvGrpSpPr>
          <p:cNvPr id="54" name="그룹 53">
            <a:extLst>
              <a:ext uri="{FF2B5EF4-FFF2-40B4-BE49-F238E27FC236}">
                <a16:creationId xmlns:a16="http://schemas.microsoft.com/office/drawing/2014/main" id="{EB567255-94E9-0B07-35EB-F062D3B6494D}"/>
              </a:ext>
            </a:extLst>
          </p:cNvPr>
          <p:cNvGrpSpPr/>
          <p:nvPr/>
        </p:nvGrpSpPr>
        <p:grpSpPr>
          <a:xfrm>
            <a:off x="3745700" y="1062040"/>
            <a:ext cx="2767203" cy="3040140"/>
            <a:chOff x="3709584" y="2075024"/>
            <a:chExt cx="2767203" cy="3040140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11BAE45D-0DC5-9269-5B09-7B412BF46B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390"/>
            <a:stretch/>
          </p:blipFill>
          <p:spPr>
            <a:xfrm>
              <a:off x="3709584" y="2437145"/>
              <a:ext cx="2767203" cy="2678019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198BF5D-24A7-A874-8D67-08A047154120}"/>
                </a:ext>
              </a:extLst>
            </p:cNvPr>
            <p:cNvSpPr txBox="1"/>
            <p:nvPr/>
          </p:nvSpPr>
          <p:spPr>
            <a:xfrm>
              <a:off x="3709584" y="2075024"/>
              <a:ext cx="2767203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D and 5E</a:t>
              </a:r>
            </a:p>
          </p:txBody>
        </p: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81EADFB4-F09E-5A7F-E5E2-717EB94F4F25}"/>
                </a:ext>
              </a:extLst>
            </p:cNvPr>
            <p:cNvGrpSpPr/>
            <p:nvPr/>
          </p:nvGrpSpPr>
          <p:grpSpPr>
            <a:xfrm>
              <a:off x="4582087" y="2915043"/>
              <a:ext cx="810791" cy="422588"/>
              <a:chOff x="3278561" y="1542267"/>
              <a:chExt cx="810791" cy="422588"/>
            </a:xfrm>
          </p:grpSpPr>
          <p:sp>
            <p:nvSpPr>
              <p:cNvPr id="14" name="직사각형 13">
                <a:extLst>
                  <a:ext uri="{FF2B5EF4-FFF2-40B4-BE49-F238E27FC236}">
                    <a16:creationId xmlns:a16="http://schemas.microsoft.com/office/drawing/2014/main" id="{B4D7A6B3-1E66-9539-6971-47832A222D35}"/>
                  </a:ext>
                </a:extLst>
              </p:cNvPr>
              <p:cNvSpPr/>
              <p:nvPr/>
            </p:nvSpPr>
            <p:spPr>
              <a:xfrm>
                <a:off x="3449175" y="1768597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5359FB4-FB40-716A-011B-583AE608F01B}"/>
                  </a:ext>
                </a:extLst>
              </p:cNvPr>
              <p:cNvSpPr txBox="1"/>
              <p:nvPr/>
            </p:nvSpPr>
            <p:spPr>
              <a:xfrm>
                <a:off x="3278561" y="1542267"/>
                <a:ext cx="8107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PINE1</a:t>
                </a:r>
              </a:p>
            </p:txBody>
          </p:sp>
        </p:grp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B197CA67-260F-263F-2744-06ADA3D9E4F5}"/>
                </a:ext>
              </a:extLst>
            </p:cNvPr>
            <p:cNvGrpSpPr/>
            <p:nvPr/>
          </p:nvGrpSpPr>
          <p:grpSpPr>
            <a:xfrm>
              <a:off x="5705231" y="4361225"/>
              <a:ext cx="651651" cy="426431"/>
              <a:chOff x="3382644" y="2448622"/>
              <a:chExt cx="651651" cy="426431"/>
            </a:xfrm>
          </p:grpSpPr>
          <p:sp>
            <p:nvSpPr>
              <p:cNvPr id="16" name="직사각형 15">
                <a:extLst>
                  <a:ext uri="{FF2B5EF4-FFF2-40B4-BE49-F238E27FC236}">
                    <a16:creationId xmlns:a16="http://schemas.microsoft.com/office/drawing/2014/main" id="{CEB51C7D-C5EC-4655-BE6B-E8C0DC64A9C5}"/>
                  </a:ext>
                </a:extLst>
              </p:cNvPr>
              <p:cNvSpPr/>
              <p:nvPr/>
            </p:nvSpPr>
            <p:spPr>
              <a:xfrm>
                <a:off x="3471957" y="2678795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7B263A6-879A-D5CA-0CE3-4DFA6A205B9A}"/>
                  </a:ext>
                </a:extLst>
              </p:cNvPr>
              <p:cNvSpPr txBox="1"/>
              <p:nvPr/>
            </p:nvSpPr>
            <p:spPr>
              <a:xfrm>
                <a:off x="3382644" y="2448622"/>
                <a:ext cx="6516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</p:grpSp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1AD20B47-E82A-F5EA-C747-597A4800EBB8}"/>
                </a:ext>
              </a:extLst>
            </p:cNvPr>
            <p:cNvGrpSpPr/>
            <p:nvPr/>
          </p:nvGrpSpPr>
          <p:grpSpPr>
            <a:xfrm>
              <a:off x="5569012" y="2904947"/>
              <a:ext cx="810791" cy="422588"/>
              <a:chOff x="3278561" y="1542267"/>
              <a:chExt cx="810791" cy="422588"/>
            </a:xfrm>
          </p:grpSpPr>
          <p:sp>
            <p:nvSpPr>
              <p:cNvPr id="20" name="직사각형 19">
                <a:extLst>
                  <a:ext uri="{FF2B5EF4-FFF2-40B4-BE49-F238E27FC236}">
                    <a16:creationId xmlns:a16="http://schemas.microsoft.com/office/drawing/2014/main" id="{2C08F867-92E4-52AC-6DEF-CFDE34DEC293}"/>
                  </a:ext>
                </a:extLst>
              </p:cNvPr>
              <p:cNvSpPr/>
              <p:nvPr/>
            </p:nvSpPr>
            <p:spPr>
              <a:xfrm>
                <a:off x="3449175" y="1768597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C008D86-1D79-830C-04EB-36455C281A48}"/>
                  </a:ext>
                </a:extLst>
              </p:cNvPr>
              <p:cNvSpPr txBox="1"/>
              <p:nvPr/>
            </p:nvSpPr>
            <p:spPr>
              <a:xfrm>
                <a:off x="3278561" y="1542267"/>
                <a:ext cx="8107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PINE1</a:t>
                </a:r>
              </a:p>
            </p:txBody>
          </p:sp>
        </p:grpSp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F9CC14D8-7634-7590-FCD3-DBC751587114}"/>
                </a:ext>
              </a:extLst>
            </p:cNvPr>
            <p:cNvGrpSpPr/>
            <p:nvPr/>
          </p:nvGrpSpPr>
          <p:grpSpPr>
            <a:xfrm>
              <a:off x="4733913" y="4340109"/>
              <a:ext cx="651651" cy="426431"/>
              <a:chOff x="3382644" y="2448622"/>
              <a:chExt cx="651651" cy="426431"/>
            </a:xfrm>
          </p:grpSpPr>
          <p:sp>
            <p:nvSpPr>
              <p:cNvPr id="24" name="직사각형 23">
                <a:extLst>
                  <a:ext uri="{FF2B5EF4-FFF2-40B4-BE49-F238E27FC236}">
                    <a16:creationId xmlns:a16="http://schemas.microsoft.com/office/drawing/2014/main" id="{28039B3F-D66B-9D2E-8A24-3303769690AD}"/>
                  </a:ext>
                </a:extLst>
              </p:cNvPr>
              <p:cNvSpPr/>
              <p:nvPr/>
            </p:nvSpPr>
            <p:spPr>
              <a:xfrm>
                <a:off x="3471957" y="2678795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24BCB43-04C3-5946-5878-368B863F886E}"/>
                  </a:ext>
                </a:extLst>
              </p:cNvPr>
              <p:cNvSpPr txBox="1"/>
              <p:nvPr/>
            </p:nvSpPr>
            <p:spPr>
              <a:xfrm>
                <a:off x="3382644" y="2448622"/>
                <a:ext cx="6516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</p:grpSp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9E243D08-5BA7-632D-F7E5-7984335A38AE}"/>
                </a:ext>
              </a:extLst>
            </p:cNvPr>
            <p:cNvSpPr/>
            <p:nvPr/>
          </p:nvSpPr>
          <p:spPr>
            <a:xfrm>
              <a:off x="5641422" y="2402853"/>
              <a:ext cx="818841" cy="2564176"/>
            </a:xfrm>
            <a:prstGeom prst="rect">
              <a:avLst/>
            </a:prstGeom>
            <a:no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31540C4-EB36-C45D-83D3-BBF544FEE83D}"/>
                </a:ext>
              </a:extLst>
            </p:cNvPr>
            <p:cNvSpPr txBox="1"/>
            <p:nvPr/>
          </p:nvSpPr>
          <p:spPr>
            <a:xfrm>
              <a:off x="5611128" y="2379188"/>
              <a:ext cx="3855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D</a:t>
              </a: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E8DC6F06-2EE6-2AEF-032E-D5B13E202A71}"/>
                </a:ext>
              </a:extLst>
            </p:cNvPr>
            <p:cNvSpPr/>
            <p:nvPr/>
          </p:nvSpPr>
          <p:spPr>
            <a:xfrm>
              <a:off x="4656336" y="2409284"/>
              <a:ext cx="818841" cy="2564176"/>
            </a:xfrm>
            <a:prstGeom prst="rect">
              <a:avLst/>
            </a:prstGeom>
            <a:no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195129A-9484-8F9A-A2D1-9C79EA65E45A}"/>
                </a:ext>
              </a:extLst>
            </p:cNvPr>
            <p:cNvSpPr txBox="1"/>
            <p:nvPr/>
          </p:nvSpPr>
          <p:spPr>
            <a:xfrm>
              <a:off x="4626042" y="2385619"/>
              <a:ext cx="3855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E</a:t>
              </a:r>
            </a:p>
          </p:txBody>
        </p:sp>
      </p:grp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636DC4E9-1380-109B-4B81-AD9260EE3E88}"/>
              </a:ext>
            </a:extLst>
          </p:cNvPr>
          <p:cNvGrpSpPr/>
          <p:nvPr/>
        </p:nvGrpSpPr>
        <p:grpSpPr>
          <a:xfrm>
            <a:off x="522140" y="4758561"/>
            <a:ext cx="2697766" cy="3754511"/>
            <a:chOff x="311828" y="5513135"/>
            <a:chExt cx="2697766" cy="3754511"/>
          </a:xfrm>
        </p:grpSpPr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595205D6-D58B-0C89-D2B4-8AA758B874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1828" y="5875508"/>
              <a:ext cx="2697766" cy="339213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12C5BAB-70A5-C62F-2F7C-250A4A25E3E2}"/>
                </a:ext>
              </a:extLst>
            </p:cNvPr>
            <p:cNvSpPr txBox="1"/>
            <p:nvPr/>
          </p:nvSpPr>
          <p:spPr>
            <a:xfrm>
              <a:off x="311828" y="5513135"/>
              <a:ext cx="2697766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B</a:t>
              </a:r>
            </a:p>
          </p:txBody>
        </p:sp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id="{22625FB4-9433-42D6-7C68-D5FA9FB7333C}"/>
                </a:ext>
              </a:extLst>
            </p:cNvPr>
            <p:cNvGrpSpPr/>
            <p:nvPr/>
          </p:nvGrpSpPr>
          <p:grpSpPr>
            <a:xfrm>
              <a:off x="1611521" y="6662852"/>
              <a:ext cx="810791" cy="422588"/>
              <a:chOff x="3278561" y="1542267"/>
              <a:chExt cx="810791" cy="422588"/>
            </a:xfrm>
          </p:grpSpPr>
          <p:sp>
            <p:nvSpPr>
              <p:cNvPr id="34" name="직사각형 33">
                <a:extLst>
                  <a:ext uri="{FF2B5EF4-FFF2-40B4-BE49-F238E27FC236}">
                    <a16:creationId xmlns:a16="http://schemas.microsoft.com/office/drawing/2014/main" id="{706944C5-C68B-5A84-D28B-4E199B7017C6}"/>
                  </a:ext>
                </a:extLst>
              </p:cNvPr>
              <p:cNvSpPr/>
              <p:nvPr/>
            </p:nvSpPr>
            <p:spPr>
              <a:xfrm>
                <a:off x="3449175" y="1768597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6C12A23-B4DE-BFDF-2C5C-F70DFB390AAA}"/>
                  </a:ext>
                </a:extLst>
              </p:cNvPr>
              <p:cNvSpPr txBox="1"/>
              <p:nvPr/>
            </p:nvSpPr>
            <p:spPr>
              <a:xfrm>
                <a:off x="3278561" y="1542267"/>
                <a:ext cx="8107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RPINE1</a:t>
                </a:r>
              </a:p>
            </p:txBody>
          </p:sp>
        </p:grpSp>
        <p:grpSp>
          <p:nvGrpSpPr>
            <p:cNvPr id="36" name="그룹 35">
              <a:extLst>
                <a:ext uri="{FF2B5EF4-FFF2-40B4-BE49-F238E27FC236}">
                  <a16:creationId xmlns:a16="http://schemas.microsoft.com/office/drawing/2014/main" id="{2F41CE83-CA52-BAA5-9098-AE478236075F}"/>
                </a:ext>
              </a:extLst>
            </p:cNvPr>
            <p:cNvGrpSpPr/>
            <p:nvPr/>
          </p:nvGrpSpPr>
          <p:grpSpPr>
            <a:xfrm>
              <a:off x="1820279" y="8486357"/>
              <a:ext cx="651651" cy="426431"/>
              <a:chOff x="3382644" y="2448622"/>
              <a:chExt cx="651651" cy="426431"/>
            </a:xfrm>
          </p:grpSpPr>
          <p:sp>
            <p:nvSpPr>
              <p:cNvPr id="37" name="직사각형 36">
                <a:extLst>
                  <a:ext uri="{FF2B5EF4-FFF2-40B4-BE49-F238E27FC236}">
                    <a16:creationId xmlns:a16="http://schemas.microsoft.com/office/drawing/2014/main" id="{14615321-4EF4-64E7-72F4-D59A3166C5A3}"/>
                  </a:ext>
                </a:extLst>
              </p:cNvPr>
              <p:cNvSpPr/>
              <p:nvPr/>
            </p:nvSpPr>
            <p:spPr>
              <a:xfrm>
                <a:off x="3471957" y="2678795"/>
                <a:ext cx="456983" cy="19625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E5CE85A-BCC8-23FD-70F0-BE759B229C75}"/>
                  </a:ext>
                </a:extLst>
              </p:cNvPr>
              <p:cNvSpPr txBox="1"/>
              <p:nvPr/>
            </p:nvSpPr>
            <p:spPr>
              <a:xfrm>
                <a:off x="3382644" y="2448622"/>
                <a:ext cx="6516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</p:grpSp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816680F6-310F-80D5-0D1D-E9760E9E0C26}"/>
              </a:ext>
            </a:extLst>
          </p:cNvPr>
          <p:cNvGrpSpPr/>
          <p:nvPr/>
        </p:nvGrpSpPr>
        <p:grpSpPr>
          <a:xfrm>
            <a:off x="4004163" y="4746419"/>
            <a:ext cx="2211863" cy="3210678"/>
            <a:chOff x="3984746" y="5869914"/>
            <a:chExt cx="2211863" cy="3210678"/>
          </a:xfrm>
        </p:grpSpPr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FEC2A12E-451E-BFFE-0764-705F4ADAE9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02155" y="6177086"/>
              <a:ext cx="2149983" cy="2903506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6406F78-0515-0A1D-AD0E-1920B7C6413D}"/>
                </a:ext>
              </a:extLst>
            </p:cNvPr>
            <p:cNvSpPr txBox="1"/>
            <p:nvPr/>
          </p:nvSpPr>
          <p:spPr>
            <a:xfrm>
              <a:off x="3984746" y="5869914"/>
              <a:ext cx="2211863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A</a:t>
              </a:r>
            </a:p>
          </p:txBody>
        </p:sp>
        <p:sp>
          <p:nvSpPr>
            <p:cNvPr id="42" name="직사각형 41">
              <a:extLst>
                <a:ext uri="{FF2B5EF4-FFF2-40B4-BE49-F238E27FC236}">
                  <a16:creationId xmlns:a16="http://schemas.microsoft.com/office/drawing/2014/main" id="{2D93A13E-015A-7C39-5BCF-C013CECCC366}"/>
                </a:ext>
              </a:extLst>
            </p:cNvPr>
            <p:cNvSpPr/>
            <p:nvPr/>
          </p:nvSpPr>
          <p:spPr>
            <a:xfrm>
              <a:off x="4524829" y="7326520"/>
              <a:ext cx="1471889" cy="27214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직사각형 44">
              <a:extLst>
                <a:ext uri="{FF2B5EF4-FFF2-40B4-BE49-F238E27FC236}">
                  <a16:creationId xmlns:a16="http://schemas.microsoft.com/office/drawing/2014/main" id="{07D92B8B-6F3A-33A3-66CD-7C8021A496CB}"/>
                </a:ext>
              </a:extLst>
            </p:cNvPr>
            <p:cNvSpPr/>
            <p:nvPr/>
          </p:nvSpPr>
          <p:spPr>
            <a:xfrm>
              <a:off x="4510313" y="8513072"/>
              <a:ext cx="1471889" cy="272143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89C0032-BAAE-E01E-7C54-FEE6002D9AF5}"/>
                </a:ext>
              </a:extLst>
            </p:cNvPr>
            <p:cNvSpPr txBox="1"/>
            <p:nvPr/>
          </p:nvSpPr>
          <p:spPr>
            <a:xfrm>
              <a:off x="5611128" y="7605475"/>
              <a:ext cx="567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B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D349D1C-3208-8B81-BB72-BE3E436A9293}"/>
                </a:ext>
              </a:extLst>
            </p:cNvPr>
            <p:cNvSpPr txBox="1"/>
            <p:nvPr/>
          </p:nvSpPr>
          <p:spPr>
            <a:xfrm>
              <a:off x="5435433" y="8783602"/>
              <a:ext cx="656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1466506F-57A6-D53F-A9D8-AE26AAAE98B7}"/>
              </a:ext>
            </a:extLst>
          </p:cNvPr>
          <p:cNvSpPr txBox="1"/>
          <p:nvPr/>
        </p:nvSpPr>
        <p:spPr>
          <a:xfrm>
            <a:off x="228600" y="237744"/>
            <a:ext cx="64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Western blot data                                                               Park &amp; Jeong et al.</a:t>
            </a:r>
          </a:p>
        </p:txBody>
      </p:sp>
    </p:spTree>
    <p:extLst>
      <p:ext uri="{BB962C8B-B14F-4D97-AF65-F5344CB8AC3E}">
        <p14:creationId xmlns:p14="http://schemas.microsoft.com/office/powerpoint/2010/main" val="27352468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F0BD65-645C-7494-770C-B53190749E63}"/>
              </a:ext>
            </a:extLst>
          </p:cNvPr>
          <p:cNvSpPr txBox="1"/>
          <p:nvPr/>
        </p:nvSpPr>
        <p:spPr>
          <a:xfrm>
            <a:off x="228600" y="237744"/>
            <a:ext cx="64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Western blot data                                                               Park &amp; Jeong et al.</a:t>
            </a:r>
          </a:p>
        </p:txBody>
      </p:sp>
      <p:grpSp>
        <p:nvGrpSpPr>
          <p:cNvPr id="48" name="그룹 47">
            <a:extLst>
              <a:ext uri="{FF2B5EF4-FFF2-40B4-BE49-F238E27FC236}">
                <a16:creationId xmlns:a16="http://schemas.microsoft.com/office/drawing/2014/main" id="{C842D789-9AA6-8D3A-42CD-48B54E30DB6A}"/>
              </a:ext>
            </a:extLst>
          </p:cNvPr>
          <p:cNvGrpSpPr/>
          <p:nvPr/>
        </p:nvGrpSpPr>
        <p:grpSpPr>
          <a:xfrm>
            <a:off x="3256637" y="993169"/>
            <a:ext cx="2929049" cy="3340176"/>
            <a:chOff x="2918147" y="1077214"/>
            <a:chExt cx="2929049" cy="3340176"/>
          </a:xfrm>
        </p:grpSpPr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58FDAF6C-C45E-CC32-8203-029B989F88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36971" y="1334781"/>
              <a:ext cx="2829533" cy="308260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6F39AC5-C782-A0BA-DB92-F701337973D8}"/>
                </a:ext>
              </a:extLst>
            </p:cNvPr>
            <p:cNvSpPr txBox="1"/>
            <p:nvPr/>
          </p:nvSpPr>
          <p:spPr>
            <a:xfrm>
              <a:off x="2918147" y="1077214"/>
              <a:ext cx="2848357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D</a:t>
              </a:r>
            </a:p>
          </p:txBody>
        </p:sp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1DC8B2E8-210E-52BE-F8E2-3E76FDEB7918}"/>
                </a:ext>
              </a:extLst>
            </p:cNvPr>
            <p:cNvSpPr/>
            <p:nvPr/>
          </p:nvSpPr>
          <p:spPr>
            <a:xfrm>
              <a:off x="4440146" y="2622835"/>
              <a:ext cx="714271" cy="36202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28324D2-4557-5158-8D58-B3D224B257B0}"/>
                </a:ext>
              </a:extLst>
            </p:cNvPr>
            <p:cNvSpPr txBox="1"/>
            <p:nvPr/>
          </p:nvSpPr>
          <p:spPr>
            <a:xfrm>
              <a:off x="5112509" y="3696520"/>
              <a:ext cx="6091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-ERK</a:t>
              </a:r>
            </a:p>
          </p:txBody>
        </p:sp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98E875FF-BFCC-8433-E274-0B3624260921}"/>
                </a:ext>
              </a:extLst>
            </p:cNvPr>
            <p:cNvSpPr/>
            <p:nvPr/>
          </p:nvSpPr>
          <p:spPr>
            <a:xfrm>
              <a:off x="4440146" y="3672819"/>
              <a:ext cx="676948" cy="29362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D39FDCC-9660-71B4-0502-ED461E7FB224}"/>
                </a:ext>
              </a:extLst>
            </p:cNvPr>
            <p:cNvSpPr txBox="1"/>
            <p:nvPr/>
          </p:nvSpPr>
          <p:spPr>
            <a:xfrm>
              <a:off x="5036405" y="2673274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59022D02-3432-FD7A-CC63-A7A0237BB07B}"/>
              </a:ext>
            </a:extLst>
          </p:cNvPr>
          <p:cNvGrpSpPr/>
          <p:nvPr/>
        </p:nvGrpSpPr>
        <p:grpSpPr>
          <a:xfrm>
            <a:off x="634326" y="994413"/>
            <a:ext cx="1699779" cy="3379974"/>
            <a:chOff x="310896" y="1096746"/>
            <a:chExt cx="1699779" cy="3379974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6DA54EC-AE5F-F0A9-F758-7EB030E16CFA}"/>
                </a:ext>
              </a:extLst>
            </p:cNvPr>
            <p:cNvSpPr txBox="1"/>
            <p:nvPr/>
          </p:nvSpPr>
          <p:spPr>
            <a:xfrm>
              <a:off x="310897" y="1096746"/>
              <a:ext cx="1542838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C</a:t>
              </a:r>
            </a:p>
          </p:txBody>
        </p:sp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3734AA6E-DFFD-92C2-7910-179208B3E2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145"/>
            <a:stretch/>
          </p:blipFill>
          <p:spPr>
            <a:xfrm>
              <a:off x="310896" y="1394799"/>
              <a:ext cx="1542838" cy="3081921"/>
            </a:xfrm>
            <a:prstGeom prst="rect">
              <a:avLst/>
            </a:prstGeom>
          </p:spPr>
        </p:pic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55BDEFF1-6508-CE13-E95C-9AADFCFFC76F}"/>
                </a:ext>
              </a:extLst>
            </p:cNvPr>
            <p:cNvSpPr/>
            <p:nvPr/>
          </p:nvSpPr>
          <p:spPr>
            <a:xfrm>
              <a:off x="604781" y="3882731"/>
              <a:ext cx="617395" cy="246221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4673637-E966-810B-C9C3-8C97DBCC9CDC}"/>
                </a:ext>
              </a:extLst>
            </p:cNvPr>
            <p:cNvSpPr txBox="1"/>
            <p:nvPr/>
          </p:nvSpPr>
          <p:spPr>
            <a:xfrm>
              <a:off x="1182674" y="3882730"/>
              <a:ext cx="6516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C82ECDE7-D863-681D-D210-72916B36F01F}"/>
                </a:ext>
              </a:extLst>
            </p:cNvPr>
            <p:cNvSpPr/>
            <p:nvPr/>
          </p:nvSpPr>
          <p:spPr>
            <a:xfrm>
              <a:off x="653668" y="2484656"/>
              <a:ext cx="651651" cy="29666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AE63CC0-7ACB-63AB-23A6-D1AD5A8F9F74}"/>
                </a:ext>
              </a:extLst>
            </p:cNvPr>
            <p:cNvSpPr txBox="1"/>
            <p:nvPr/>
          </p:nvSpPr>
          <p:spPr>
            <a:xfrm>
              <a:off x="1199884" y="2525997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-YB1</a:t>
              </a: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08206B83-13A1-15B9-1665-142589A0C677}"/>
                </a:ext>
              </a:extLst>
            </p:cNvPr>
            <p:cNvSpPr/>
            <p:nvPr/>
          </p:nvSpPr>
          <p:spPr>
            <a:xfrm>
              <a:off x="617272" y="3015648"/>
              <a:ext cx="651651" cy="29666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B38A56B-0866-43CF-6B56-08E67127660E}"/>
                </a:ext>
              </a:extLst>
            </p:cNvPr>
            <p:cNvSpPr txBox="1"/>
            <p:nvPr/>
          </p:nvSpPr>
          <p:spPr>
            <a:xfrm>
              <a:off x="1168037" y="3047891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YB1</a:t>
              </a:r>
            </a:p>
          </p:txBody>
        </p:sp>
      </p:grpSp>
      <p:grpSp>
        <p:nvGrpSpPr>
          <p:cNvPr id="49" name="그룹 48">
            <a:extLst>
              <a:ext uri="{FF2B5EF4-FFF2-40B4-BE49-F238E27FC236}">
                <a16:creationId xmlns:a16="http://schemas.microsoft.com/office/drawing/2014/main" id="{A77469E8-640F-B085-F5E9-FF60B249E161}"/>
              </a:ext>
            </a:extLst>
          </p:cNvPr>
          <p:cNvGrpSpPr/>
          <p:nvPr/>
        </p:nvGrpSpPr>
        <p:grpSpPr>
          <a:xfrm>
            <a:off x="543076" y="4895068"/>
            <a:ext cx="2930739" cy="4224010"/>
            <a:chOff x="268405" y="4907523"/>
            <a:chExt cx="2930739" cy="4224010"/>
          </a:xfrm>
        </p:grpSpPr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C4208F98-8581-75C4-73A8-3F3D67E25E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762"/>
            <a:stretch/>
          </p:blipFill>
          <p:spPr>
            <a:xfrm>
              <a:off x="268405" y="5169133"/>
              <a:ext cx="2552704" cy="3962400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5C20275-45D0-2D07-B72F-0C6F36A7910C}"/>
                </a:ext>
              </a:extLst>
            </p:cNvPr>
            <p:cNvSpPr txBox="1"/>
            <p:nvPr/>
          </p:nvSpPr>
          <p:spPr>
            <a:xfrm>
              <a:off x="268405" y="4907523"/>
              <a:ext cx="2930739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E</a:t>
              </a:r>
            </a:p>
          </p:txBody>
        </p:sp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C05D9A22-AB9E-532F-AD33-D809C610705A}"/>
                </a:ext>
              </a:extLst>
            </p:cNvPr>
            <p:cNvSpPr/>
            <p:nvPr/>
          </p:nvSpPr>
          <p:spPr>
            <a:xfrm>
              <a:off x="1168037" y="6402326"/>
              <a:ext cx="1247617" cy="380217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2045F81-4388-7721-0126-B57A7180DC14}"/>
                </a:ext>
              </a:extLst>
            </p:cNvPr>
            <p:cNvSpPr txBox="1"/>
            <p:nvPr/>
          </p:nvSpPr>
          <p:spPr>
            <a:xfrm>
              <a:off x="2271350" y="6469323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B1</a:t>
              </a:r>
            </a:p>
          </p:txBody>
        </p:sp>
        <p:sp>
          <p:nvSpPr>
            <p:cNvPr id="34" name="직사각형 33">
              <a:extLst>
                <a:ext uri="{FF2B5EF4-FFF2-40B4-BE49-F238E27FC236}">
                  <a16:creationId xmlns:a16="http://schemas.microsoft.com/office/drawing/2014/main" id="{40DBC143-F73D-BFDF-CB7C-378BF193BD4E}"/>
                </a:ext>
              </a:extLst>
            </p:cNvPr>
            <p:cNvSpPr/>
            <p:nvPr/>
          </p:nvSpPr>
          <p:spPr>
            <a:xfrm>
              <a:off x="1143015" y="7314453"/>
              <a:ext cx="1247617" cy="380217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직사각형 34">
              <a:extLst>
                <a:ext uri="{FF2B5EF4-FFF2-40B4-BE49-F238E27FC236}">
                  <a16:creationId xmlns:a16="http://schemas.microsoft.com/office/drawing/2014/main" id="{2212DA5A-3AA1-09A8-183E-F06F74FBB666}"/>
                </a:ext>
              </a:extLst>
            </p:cNvPr>
            <p:cNvSpPr/>
            <p:nvPr/>
          </p:nvSpPr>
          <p:spPr>
            <a:xfrm>
              <a:off x="1140736" y="8399453"/>
              <a:ext cx="1247617" cy="380217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A4EBD4E-A0CD-76E5-76C4-8181799985B4}"/>
                </a:ext>
              </a:extLst>
            </p:cNvPr>
            <p:cNvSpPr txBox="1"/>
            <p:nvPr/>
          </p:nvSpPr>
          <p:spPr>
            <a:xfrm>
              <a:off x="2357784" y="7378695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min B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90F6732-B7D6-D4D5-748B-640ECD28D167}"/>
                </a:ext>
              </a:extLst>
            </p:cNvPr>
            <p:cNvSpPr txBox="1"/>
            <p:nvPr/>
          </p:nvSpPr>
          <p:spPr>
            <a:xfrm>
              <a:off x="2388353" y="8472079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FF775981-F0C8-1AFE-DADB-2B33D0F1EA64}"/>
              </a:ext>
            </a:extLst>
          </p:cNvPr>
          <p:cNvGrpSpPr/>
          <p:nvPr/>
        </p:nvGrpSpPr>
        <p:grpSpPr>
          <a:xfrm>
            <a:off x="3690873" y="4879111"/>
            <a:ext cx="2828052" cy="3367042"/>
            <a:chOff x="3670401" y="4879111"/>
            <a:chExt cx="2828052" cy="336704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B64255A-6A60-2AD3-5DB9-0D139C847D94}"/>
                </a:ext>
              </a:extLst>
            </p:cNvPr>
            <p:cNvSpPr txBox="1"/>
            <p:nvPr/>
          </p:nvSpPr>
          <p:spPr>
            <a:xfrm>
              <a:off x="3670401" y="4879111"/>
              <a:ext cx="2795152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G</a:t>
              </a:r>
            </a:p>
          </p:txBody>
        </p: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37CBB0AB-E92A-2446-C29B-D436A29D27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15"/>
            <a:stretch/>
          </p:blipFill>
          <p:spPr>
            <a:xfrm>
              <a:off x="3670401" y="5294023"/>
              <a:ext cx="2552704" cy="2952130"/>
            </a:xfrm>
            <a:prstGeom prst="rect">
              <a:avLst/>
            </a:prstGeom>
          </p:spPr>
        </p:pic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89EE9883-C51B-467A-6507-FFA2224E94E7}"/>
                </a:ext>
              </a:extLst>
            </p:cNvPr>
            <p:cNvSpPr/>
            <p:nvPr/>
          </p:nvSpPr>
          <p:spPr>
            <a:xfrm>
              <a:off x="5322887" y="5977922"/>
              <a:ext cx="474231" cy="29666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DD6EE10-DE59-A2B7-75BB-B6221DE0752F}"/>
                </a:ext>
              </a:extLst>
            </p:cNvPr>
            <p:cNvSpPr txBox="1"/>
            <p:nvPr/>
          </p:nvSpPr>
          <p:spPr>
            <a:xfrm>
              <a:off x="5654762" y="6000046"/>
              <a:ext cx="810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B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9BBD567-9912-5904-A577-A8C34C2775A1}"/>
                </a:ext>
              </a:extLst>
            </p:cNvPr>
            <p:cNvSpPr txBox="1"/>
            <p:nvPr/>
          </p:nvSpPr>
          <p:spPr>
            <a:xfrm>
              <a:off x="5811913" y="6770088"/>
              <a:ext cx="585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YB1</a:t>
              </a:r>
            </a:p>
          </p:txBody>
        </p:sp>
        <p:sp>
          <p:nvSpPr>
            <p:cNvPr id="23" name="직사각형 22">
              <a:extLst>
                <a:ext uri="{FF2B5EF4-FFF2-40B4-BE49-F238E27FC236}">
                  <a16:creationId xmlns:a16="http://schemas.microsoft.com/office/drawing/2014/main" id="{DE0AF451-2452-3AE7-C0FC-DFD1CFEAACBC}"/>
                </a:ext>
              </a:extLst>
            </p:cNvPr>
            <p:cNvSpPr/>
            <p:nvPr/>
          </p:nvSpPr>
          <p:spPr>
            <a:xfrm>
              <a:off x="5366962" y="6770088"/>
              <a:ext cx="474231" cy="29666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FF1A3F6-D3F2-1FE2-E2CD-1AF2706B7052}"/>
                </a:ext>
              </a:extLst>
            </p:cNvPr>
            <p:cNvSpPr txBox="1"/>
            <p:nvPr/>
          </p:nvSpPr>
          <p:spPr>
            <a:xfrm>
              <a:off x="5844842" y="7584651"/>
              <a:ext cx="6536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78FC4110-5D39-E38E-C078-641370F3B089}"/>
                </a:ext>
              </a:extLst>
            </p:cNvPr>
            <p:cNvSpPr/>
            <p:nvPr/>
          </p:nvSpPr>
          <p:spPr>
            <a:xfrm>
              <a:off x="5399892" y="7584651"/>
              <a:ext cx="474231" cy="29666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017958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F7226A-D767-B919-9B39-3C2FE42D7AE5}"/>
              </a:ext>
            </a:extLst>
          </p:cNvPr>
          <p:cNvSpPr txBox="1"/>
          <p:nvPr/>
        </p:nvSpPr>
        <p:spPr>
          <a:xfrm>
            <a:off x="228600" y="237744"/>
            <a:ext cx="64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Western blot data                                                               Park &amp; Jeong et al.</a:t>
            </a: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D8D01194-3C25-662A-446C-32278316837E}"/>
              </a:ext>
            </a:extLst>
          </p:cNvPr>
          <p:cNvGrpSpPr/>
          <p:nvPr/>
        </p:nvGrpSpPr>
        <p:grpSpPr>
          <a:xfrm>
            <a:off x="3870661" y="1021602"/>
            <a:ext cx="2192382" cy="2916268"/>
            <a:chOff x="228600" y="1268042"/>
            <a:chExt cx="2192382" cy="2916268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725E5670-774B-A3C4-E94B-E1090B4D2F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8600" y="1466041"/>
              <a:ext cx="2192382" cy="2718269"/>
            </a:xfrm>
            <a:prstGeom prst="rect">
              <a:avLst/>
            </a:prstGeom>
          </p:spPr>
        </p:pic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715241A8-4DB0-A049-507F-BF3ED621768A}"/>
                </a:ext>
              </a:extLst>
            </p:cNvPr>
            <p:cNvSpPr/>
            <p:nvPr/>
          </p:nvSpPr>
          <p:spPr>
            <a:xfrm>
              <a:off x="1082316" y="2668566"/>
              <a:ext cx="451783" cy="23162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F90F693-9C71-3446-9030-D4E0994404F2}"/>
                </a:ext>
              </a:extLst>
            </p:cNvPr>
            <p:cNvSpPr txBox="1"/>
            <p:nvPr/>
          </p:nvSpPr>
          <p:spPr>
            <a:xfrm>
              <a:off x="1491509" y="2538157"/>
              <a:ext cx="4860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B1</a:t>
              </a:r>
            </a:p>
          </p:txBody>
        </p:sp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E4981915-A234-EF30-BA9A-EBCAD8241A33}"/>
                </a:ext>
              </a:extLst>
            </p:cNvPr>
            <p:cNvSpPr/>
            <p:nvPr/>
          </p:nvSpPr>
          <p:spPr>
            <a:xfrm>
              <a:off x="1082316" y="3532506"/>
              <a:ext cx="451783" cy="23162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74603C9-EEB6-73A3-E77A-C994F9E7C37D}"/>
                </a:ext>
              </a:extLst>
            </p:cNvPr>
            <p:cNvSpPr txBox="1"/>
            <p:nvPr/>
          </p:nvSpPr>
          <p:spPr>
            <a:xfrm>
              <a:off x="1308207" y="3285131"/>
              <a:ext cx="7140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15ED637-2255-96BB-F1ED-F3F870A852F6}"/>
                </a:ext>
              </a:extLst>
            </p:cNvPr>
            <p:cNvSpPr txBox="1"/>
            <p:nvPr/>
          </p:nvSpPr>
          <p:spPr>
            <a:xfrm>
              <a:off x="252604" y="1268042"/>
              <a:ext cx="2168377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J</a:t>
              </a:r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91A5F833-6BBF-24E3-9436-D41DF82BF854}"/>
              </a:ext>
            </a:extLst>
          </p:cNvPr>
          <p:cNvGrpSpPr/>
          <p:nvPr/>
        </p:nvGrpSpPr>
        <p:grpSpPr>
          <a:xfrm>
            <a:off x="866136" y="5803478"/>
            <a:ext cx="2562864" cy="3430511"/>
            <a:chOff x="3212820" y="1466041"/>
            <a:chExt cx="2562864" cy="3430511"/>
          </a:xfrm>
        </p:grpSpPr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7B2D5DFA-6425-26F4-280B-0158EF825D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91214" y="1796955"/>
              <a:ext cx="2484470" cy="3099597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A95659A-2BE2-9B97-02F8-DF13AEEFE41D}"/>
                </a:ext>
              </a:extLst>
            </p:cNvPr>
            <p:cNvSpPr txBox="1"/>
            <p:nvPr/>
          </p:nvSpPr>
          <p:spPr>
            <a:xfrm>
              <a:off x="3212820" y="1466041"/>
              <a:ext cx="2562863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ry 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12C</a:t>
              </a: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72DF23E4-3097-2957-303C-3937095059F2}"/>
                </a:ext>
              </a:extLst>
            </p:cNvPr>
            <p:cNvSpPr/>
            <p:nvPr/>
          </p:nvSpPr>
          <p:spPr>
            <a:xfrm>
              <a:off x="4027982" y="3121222"/>
              <a:ext cx="898860" cy="29072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9F9B30F-E6D4-6A16-A84F-6C49CFB27010}"/>
                </a:ext>
              </a:extLst>
            </p:cNvPr>
            <p:cNvSpPr txBox="1"/>
            <p:nvPr/>
          </p:nvSpPr>
          <p:spPr>
            <a:xfrm>
              <a:off x="4983813" y="3143471"/>
              <a:ext cx="6433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ARP</a:t>
              </a:r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94BF900E-009E-1283-9EED-1C34614549BA}"/>
                </a:ext>
              </a:extLst>
            </p:cNvPr>
            <p:cNvSpPr/>
            <p:nvPr/>
          </p:nvSpPr>
          <p:spPr>
            <a:xfrm>
              <a:off x="4048453" y="4110689"/>
              <a:ext cx="898860" cy="29072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D35A889-9A64-8151-36B7-8129BB6A2B39}"/>
                </a:ext>
              </a:extLst>
            </p:cNvPr>
            <p:cNvSpPr txBox="1"/>
            <p:nvPr/>
          </p:nvSpPr>
          <p:spPr>
            <a:xfrm>
              <a:off x="5040676" y="4142039"/>
              <a:ext cx="6433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0418689E-8DCE-9684-937F-8395C0030E22}"/>
              </a:ext>
            </a:extLst>
          </p:cNvPr>
          <p:cNvGrpSpPr/>
          <p:nvPr/>
        </p:nvGrpSpPr>
        <p:grpSpPr>
          <a:xfrm>
            <a:off x="862428" y="1018347"/>
            <a:ext cx="2299411" cy="4292263"/>
            <a:chOff x="3924422" y="4998242"/>
            <a:chExt cx="2299411" cy="4292263"/>
          </a:xfrm>
        </p:grpSpPr>
        <p:pic>
          <p:nvPicPr>
            <p:cNvPr id="39" name="그림 38">
              <a:extLst>
                <a:ext uri="{FF2B5EF4-FFF2-40B4-BE49-F238E27FC236}">
                  <a16:creationId xmlns:a16="http://schemas.microsoft.com/office/drawing/2014/main" id="{97269E6E-A6B7-24BA-67CE-DDDF167006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24422" y="5272586"/>
              <a:ext cx="2299411" cy="4017919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A25F83A-59BA-0576-F887-782D614CEBDE}"/>
                </a:ext>
              </a:extLst>
            </p:cNvPr>
            <p:cNvSpPr txBox="1"/>
            <p:nvPr/>
          </p:nvSpPr>
          <p:spPr>
            <a:xfrm>
              <a:off x="3924422" y="4998242"/>
              <a:ext cx="2299411" cy="26161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>
                <a:tabLst>
                  <a:tab pos="987425" algn="l"/>
                </a:tabLst>
              </a:pP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I</a:t>
              </a:r>
            </a:p>
          </p:txBody>
        </p:sp>
        <p:sp>
          <p:nvSpPr>
            <p:cNvPr id="41" name="직사각형 40">
              <a:extLst>
                <a:ext uri="{FF2B5EF4-FFF2-40B4-BE49-F238E27FC236}">
                  <a16:creationId xmlns:a16="http://schemas.microsoft.com/office/drawing/2014/main" id="{EFB3FD63-04B9-DB92-6C8C-4B6F09F60005}"/>
                </a:ext>
              </a:extLst>
            </p:cNvPr>
            <p:cNvSpPr/>
            <p:nvPr/>
          </p:nvSpPr>
          <p:spPr>
            <a:xfrm>
              <a:off x="4825636" y="6742842"/>
              <a:ext cx="501539" cy="31321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5E8BDFD-12B8-DE57-4346-C80ACD08FA7F}"/>
                </a:ext>
              </a:extLst>
            </p:cNvPr>
            <p:cNvSpPr txBox="1"/>
            <p:nvPr/>
          </p:nvSpPr>
          <p:spPr>
            <a:xfrm>
              <a:off x="4727702" y="6497293"/>
              <a:ext cx="7140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B1</a:t>
              </a:r>
            </a:p>
          </p:txBody>
        </p:sp>
        <p:sp>
          <p:nvSpPr>
            <p:cNvPr id="43" name="직사각형 42">
              <a:extLst>
                <a:ext uri="{FF2B5EF4-FFF2-40B4-BE49-F238E27FC236}">
                  <a16:creationId xmlns:a16="http://schemas.microsoft.com/office/drawing/2014/main" id="{2858428C-F8ED-2254-D5D6-44C03C6CBB7C}"/>
                </a:ext>
              </a:extLst>
            </p:cNvPr>
            <p:cNvSpPr/>
            <p:nvPr/>
          </p:nvSpPr>
          <p:spPr>
            <a:xfrm>
              <a:off x="4768770" y="7659521"/>
              <a:ext cx="501539" cy="31321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직사각형 43">
              <a:extLst>
                <a:ext uri="{FF2B5EF4-FFF2-40B4-BE49-F238E27FC236}">
                  <a16:creationId xmlns:a16="http://schemas.microsoft.com/office/drawing/2014/main" id="{CFF4F26F-7E43-A107-0B5A-FBCCE15D70F6}"/>
                </a:ext>
              </a:extLst>
            </p:cNvPr>
            <p:cNvSpPr/>
            <p:nvPr/>
          </p:nvSpPr>
          <p:spPr>
            <a:xfrm>
              <a:off x="4766494" y="8585296"/>
              <a:ext cx="501539" cy="31321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9D7268C-3DA3-42B4-3E4B-3B4D4FC2514F}"/>
                </a:ext>
              </a:extLst>
            </p:cNvPr>
            <p:cNvSpPr txBox="1"/>
            <p:nvPr/>
          </p:nvSpPr>
          <p:spPr>
            <a:xfrm>
              <a:off x="4648092" y="7404869"/>
              <a:ext cx="7140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YB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C9F5506-EA69-C7CA-840F-1FE813862A6D}"/>
                </a:ext>
              </a:extLst>
            </p:cNvPr>
            <p:cNvSpPr txBox="1"/>
            <p:nvPr/>
          </p:nvSpPr>
          <p:spPr>
            <a:xfrm>
              <a:off x="4679934" y="8351128"/>
              <a:ext cx="7140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0121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</TotalTime>
  <Words>86</Words>
  <Application>Microsoft Office PowerPoint</Application>
  <PresentationFormat>A4 용지(210x297mm)</PresentationFormat>
  <Paragraphs>44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맑은 고딕</vt:lpstr>
      <vt:lpstr>Arial</vt:lpstr>
      <vt:lpstr>Symbo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on Ho Kim</dc:creator>
  <cp:lastModifiedBy>Hyeon Ho Kim</cp:lastModifiedBy>
  <cp:revision>6</cp:revision>
  <dcterms:created xsi:type="dcterms:W3CDTF">2024-04-05T04:39:47Z</dcterms:created>
  <dcterms:modified xsi:type="dcterms:W3CDTF">2024-10-04T04:37:06Z</dcterms:modified>
</cp:coreProperties>
</file>